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4679950" cy="1800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8" userDrawn="1">
          <p15:clr>
            <a:srgbClr val="A4A3A4"/>
          </p15:clr>
        </p15:guide>
        <p15:guide id="2" pos="998" userDrawn="1">
          <p15:clr>
            <a:srgbClr val="A4A3A4"/>
          </p15:clr>
        </p15:guide>
        <p15:guide id="3" pos="1950" userDrawn="1">
          <p15:clr>
            <a:srgbClr val="A4A3A4"/>
          </p15:clr>
        </p15:guide>
        <p15:guide id="4" orient="horz" pos="1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254" d="100"/>
          <a:sy n="254" d="100"/>
        </p:scale>
        <p:origin x="198" y="1398"/>
      </p:cViewPr>
      <p:guideLst>
        <p:guide orient="horz" pos="408"/>
        <p:guide pos="998"/>
        <p:guide pos="1950"/>
        <p:guide orient="horz" pos="1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4994" y="294620"/>
            <a:ext cx="3509963" cy="626745"/>
          </a:xfrm>
        </p:spPr>
        <p:txBody>
          <a:bodyPr anchor="b"/>
          <a:lstStyle>
            <a:lvl1pPr algn="ctr">
              <a:defRPr sz="1575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4994" y="945535"/>
            <a:ext cx="3509963" cy="434638"/>
          </a:xfrm>
        </p:spPr>
        <p:txBody>
          <a:bodyPr/>
          <a:lstStyle>
            <a:lvl1pPr marL="0" indent="0" algn="ctr">
              <a:buNone/>
              <a:defRPr sz="630"/>
            </a:lvl1pPr>
            <a:lvl2pPr marL="120015" indent="0" algn="ctr">
              <a:buNone/>
              <a:defRPr sz="525"/>
            </a:lvl2pPr>
            <a:lvl3pPr marL="240030" indent="0" algn="ctr">
              <a:buNone/>
              <a:defRPr sz="472"/>
            </a:lvl3pPr>
            <a:lvl4pPr marL="360045" indent="0" algn="ctr">
              <a:buNone/>
              <a:defRPr sz="420"/>
            </a:lvl4pPr>
            <a:lvl5pPr marL="480060" indent="0" algn="ctr">
              <a:buNone/>
              <a:defRPr sz="420"/>
            </a:lvl5pPr>
            <a:lvl6pPr marL="600075" indent="0" algn="ctr">
              <a:buNone/>
              <a:defRPr sz="420"/>
            </a:lvl6pPr>
            <a:lvl7pPr marL="720090" indent="0" algn="ctr">
              <a:buNone/>
              <a:defRPr sz="420"/>
            </a:lvl7pPr>
            <a:lvl8pPr marL="840105" indent="0" algn="ctr">
              <a:buNone/>
              <a:defRPr sz="420"/>
            </a:lvl8pPr>
            <a:lvl9pPr marL="960120" indent="0" algn="ctr">
              <a:buNone/>
              <a:defRPr sz="42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8220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145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49089" y="95846"/>
            <a:ext cx="1009114" cy="152560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1747" y="95846"/>
            <a:ext cx="2968843" cy="152560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5473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99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9309" y="448807"/>
            <a:ext cx="4036457" cy="748843"/>
          </a:xfrm>
        </p:spPr>
        <p:txBody>
          <a:bodyPr anchor="b"/>
          <a:lstStyle>
            <a:lvl1pPr>
              <a:defRPr sz="1575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9309" y="1204734"/>
            <a:ext cx="4036457" cy="393799"/>
          </a:xfrm>
        </p:spPr>
        <p:txBody>
          <a:bodyPr/>
          <a:lstStyle>
            <a:lvl1pPr marL="0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1pPr>
            <a:lvl2pPr marL="120015" indent="0">
              <a:buNone/>
              <a:defRPr sz="525">
                <a:solidFill>
                  <a:schemeClr val="tx1">
                    <a:tint val="75000"/>
                  </a:schemeClr>
                </a:solidFill>
              </a:defRPr>
            </a:lvl2pPr>
            <a:lvl3pPr marL="240030" indent="0">
              <a:buNone/>
              <a:defRPr sz="472">
                <a:solidFill>
                  <a:schemeClr val="tx1">
                    <a:tint val="75000"/>
                  </a:schemeClr>
                </a:solidFill>
              </a:defRPr>
            </a:lvl3pPr>
            <a:lvl4pPr marL="36004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4pPr>
            <a:lvl5pPr marL="48006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5pPr>
            <a:lvl6pPr marL="60007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6pPr>
            <a:lvl7pPr marL="72009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7pPr>
            <a:lvl8pPr marL="840105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8pPr>
            <a:lvl9pPr marL="960120" indent="0">
              <a:buNone/>
              <a:defRPr sz="4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8154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1746" y="479227"/>
            <a:ext cx="1988979" cy="114222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69225" y="479227"/>
            <a:ext cx="1988979" cy="114222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823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95846"/>
            <a:ext cx="4036457" cy="347960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2356" y="441305"/>
            <a:ext cx="197983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2356" y="657582"/>
            <a:ext cx="1979838" cy="967204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69225" y="441305"/>
            <a:ext cx="1989588" cy="216277"/>
          </a:xfrm>
        </p:spPr>
        <p:txBody>
          <a:bodyPr anchor="b"/>
          <a:lstStyle>
            <a:lvl1pPr marL="0" indent="0">
              <a:buNone/>
              <a:defRPr sz="630" b="1"/>
            </a:lvl1pPr>
            <a:lvl2pPr marL="120015" indent="0">
              <a:buNone/>
              <a:defRPr sz="525" b="1"/>
            </a:lvl2pPr>
            <a:lvl3pPr marL="240030" indent="0">
              <a:buNone/>
              <a:defRPr sz="472" b="1"/>
            </a:lvl3pPr>
            <a:lvl4pPr marL="360045" indent="0">
              <a:buNone/>
              <a:defRPr sz="420" b="1"/>
            </a:lvl4pPr>
            <a:lvl5pPr marL="480060" indent="0">
              <a:buNone/>
              <a:defRPr sz="420" b="1"/>
            </a:lvl5pPr>
            <a:lvl6pPr marL="600075" indent="0">
              <a:buNone/>
              <a:defRPr sz="420" b="1"/>
            </a:lvl6pPr>
            <a:lvl7pPr marL="720090" indent="0">
              <a:buNone/>
              <a:defRPr sz="420" b="1"/>
            </a:lvl7pPr>
            <a:lvl8pPr marL="840105" indent="0">
              <a:buNone/>
              <a:defRPr sz="420" b="1"/>
            </a:lvl8pPr>
            <a:lvl9pPr marL="960120" indent="0">
              <a:buNone/>
              <a:defRPr sz="42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69225" y="657582"/>
            <a:ext cx="1989588" cy="967204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915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549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0280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89588" y="259199"/>
            <a:ext cx="2369225" cy="1279327"/>
          </a:xfrm>
        </p:spPr>
        <p:txBody>
          <a:bodyPr/>
          <a:lstStyle>
            <a:lvl1pPr>
              <a:defRPr sz="840"/>
            </a:lvl1pPr>
            <a:lvl2pPr>
              <a:defRPr sz="735"/>
            </a:lvl2pPr>
            <a:lvl3pPr>
              <a:defRPr sz="630"/>
            </a:lvl3pPr>
            <a:lvl4pPr>
              <a:defRPr sz="525"/>
            </a:lvl4pPr>
            <a:lvl5pPr>
              <a:defRPr sz="525"/>
            </a:lvl5pPr>
            <a:lvl6pPr>
              <a:defRPr sz="525"/>
            </a:lvl6pPr>
            <a:lvl7pPr>
              <a:defRPr sz="525"/>
            </a:lvl7pPr>
            <a:lvl8pPr>
              <a:defRPr sz="525"/>
            </a:lvl8pPr>
            <a:lvl9pPr>
              <a:defRPr sz="525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7551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2356" y="120015"/>
            <a:ext cx="1509406" cy="420053"/>
          </a:xfrm>
        </p:spPr>
        <p:txBody>
          <a:bodyPr anchor="b"/>
          <a:lstStyle>
            <a:lvl1pPr>
              <a:defRPr sz="84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89588" y="259199"/>
            <a:ext cx="2369225" cy="1279327"/>
          </a:xfrm>
        </p:spPr>
        <p:txBody>
          <a:bodyPr anchor="t"/>
          <a:lstStyle>
            <a:lvl1pPr marL="0" indent="0">
              <a:buNone/>
              <a:defRPr sz="840"/>
            </a:lvl1pPr>
            <a:lvl2pPr marL="120015" indent="0">
              <a:buNone/>
              <a:defRPr sz="735"/>
            </a:lvl2pPr>
            <a:lvl3pPr marL="240030" indent="0">
              <a:buNone/>
              <a:defRPr sz="630"/>
            </a:lvl3pPr>
            <a:lvl4pPr marL="360045" indent="0">
              <a:buNone/>
              <a:defRPr sz="525"/>
            </a:lvl4pPr>
            <a:lvl5pPr marL="480060" indent="0">
              <a:buNone/>
              <a:defRPr sz="525"/>
            </a:lvl5pPr>
            <a:lvl6pPr marL="600075" indent="0">
              <a:buNone/>
              <a:defRPr sz="525"/>
            </a:lvl6pPr>
            <a:lvl7pPr marL="720090" indent="0">
              <a:buNone/>
              <a:defRPr sz="525"/>
            </a:lvl7pPr>
            <a:lvl8pPr marL="840105" indent="0">
              <a:buNone/>
              <a:defRPr sz="525"/>
            </a:lvl8pPr>
            <a:lvl9pPr marL="960120" indent="0">
              <a:buNone/>
              <a:defRPr sz="525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2356" y="540067"/>
            <a:ext cx="1509406" cy="1000542"/>
          </a:xfrm>
        </p:spPr>
        <p:txBody>
          <a:bodyPr/>
          <a:lstStyle>
            <a:lvl1pPr marL="0" indent="0">
              <a:buNone/>
              <a:defRPr sz="420"/>
            </a:lvl1pPr>
            <a:lvl2pPr marL="120015" indent="0">
              <a:buNone/>
              <a:defRPr sz="368"/>
            </a:lvl2pPr>
            <a:lvl3pPr marL="240030" indent="0">
              <a:buNone/>
              <a:defRPr sz="315"/>
            </a:lvl3pPr>
            <a:lvl4pPr marL="360045" indent="0">
              <a:buNone/>
              <a:defRPr sz="263"/>
            </a:lvl4pPr>
            <a:lvl5pPr marL="480060" indent="0">
              <a:buNone/>
              <a:defRPr sz="263"/>
            </a:lvl5pPr>
            <a:lvl6pPr marL="600075" indent="0">
              <a:buNone/>
              <a:defRPr sz="263"/>
            </a:lvl6pPr>
            <a:lvl7pPr marL="720090" indent="0">
              <a:buNone/>
              <a:defRPr sz="263"/>
            </a:lvl7pPr>
            <a:lvl8pPr marL="840105" indent="0">
              <a:buNone/>
              <a:defRPr sz="263"/>
            </a:lvl8pPr>
            <a:lvl9pPr marL="960120" indent="0">
              <a:buNone/>
              <a:defRPr sz="263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389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1747" y="95846"/>
            <a:ext cx="4036457" cy="3479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1747" y="479227"/>
            <a:ext cx="4036457" cy="11422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1746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0D2B3-DDCB-4D24-A9C6-C379CDC6EF51}" type="datetimeFigureOut">
              <a:rPr lang="en-GB" smtClean="0"/>
              <a:t>02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50234" y="1668542"/>
            <a:ext cx="1579483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305215" y="1668542"/>
            <a:ext cx="1052989" cy="9584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D8D87-C316-41B9-8F88-A741DD4E742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591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40030" rtl="0" eaLnBrk="1" latinLnBrk="0" hangingPunct="1">
        <a:lnSpc>
          <a:spcPct val="90000"/>
        </a:lnSpc>
        <a:spcBef>
          <a:spcPct val="0"/>
        </a:spcBef>
        <a:buNone/>
        <a:defRPr sz="11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008" indent="-60008" algn="l" defTabSz="240030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735" kern="1200">
          <a:solidFill>
            <a:schemeClr val="tx1"/>
          </a:solidFill>
          <a:latin typeface="+mn-lt"/>
          <a:ea typeface="+mn-ea"/>
          <a:cs typeface="+mn-cs"/>
        </a:defRPr>
      </a:lvl1pPr>
      <a:lvl2pPr marL="18002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2pPr>
      <a:lvl3pPr marL="30003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525" kern="1200">
          <a:solidFill>
            <a:schemeClr val="tx1"/>
          </a:solidFill>
          <a:latin typeface="+mn-lt"/>
          <a:ea typeface="+mn-ea"/>
          <a:cs typeface="+mn-cs"/>
        </a:defRPr>
      </a:lvl3pPr>
      <a:lvl4pPr marL="42005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54006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6008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8009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900113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1020128" indent="-60008" algn="l" defTabSz="240030" rtl="0" eaLnBrk="1" latinLnBrk="0" hangingPunct="1">
        <a:lnSpc>
          <a:spcPct val="90000"/>
        </a:lnSpc>
        <a:spcBef>
          <a:spcPts val="131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1pPr>
      <a:lvl2pPr marL="12001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2pPr>
      <a:lvl3pPr marL="24003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4pPr>
      <a:lvl5pPr marL="48006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5pPr>
      <a:lvl6pPr marL="60007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6pPr>
      <a:lvl7pPr marL="72009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7pPr>
      <a:lvl8pPr marL="840105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8pPr>
      <a:lvl9pPr marL="960120" algn="l" defTabSz="240030" rtl="0" eaLnBrk="1" latinLnBrk="0" hangingPunct="1">
        <a:defRPr sz="4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kstfelt 1">
            <a:extLst>
              <a:ext uri="{FF2B5EF4-FFF2-40B4-BE49-F238E27FC236}">
                <a16:creationId xmlns:a16="http://schemas.microsoft.com/office/drawing/2014/main" id="{99C341EB-063A-4C3A-93E9-98E91611059F}"/>
              </a:ext>
            </a:extLst>
          </p:cNvPr>
          <p:cNvSpPr txBox="1"/>
          <p:nvPr/>
        </p:nvSpPr>
        <p:spPr>
          <a:xfrm>
            <a:off x="1" y="-36576"/>
            <a:ext cx="467994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800" b="1" dirty="0">
                <a:latin typeface="Arial" panose="020B0604020202020204" pitchFamily="34" charset="0"/>
                <a:cs typeface="Arial" panose="020B0604020202020204" pitchFamily="34" charset="0"/>
              </a:rPr>
              <a:t>The Copenhagen General Population Study</a:t>
            </a:r>
          </a:p>
          <a:p>
            <a:pPr algn="ctr"/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25,656 individuals not 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taking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 lipid-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lowering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 20–100 years, and 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da-DK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metabolomic</a:t>
            </a:r>
            <a:r>
              <a:rPr lang="da-DK" sz="700" i="1" dirty="0">
                <a:latin typeface="Arial" panose="020B0604020202020204" pitchFamily="34" charset="0"/>
                <a:cs typeface="Arial" panose="020B0604020202020204" pitchFamily="34" charset="0"/>
              </a:rPr>
              <a:t> profiling</a:t>
            </a:r>
            <a:endParaRPr lang="en-GB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Billedforklaring: nedadgående pil 2">
            <a:extLst>
              <a:ext uri="{FF2B5EF4-FFF2-40B4-BE49-F238E27FC236}">
                <a16:creationId xmlns:a16="http://schemas.microsoft.com/office/drawing/2014/main" id="{FD706BD9-DFD6-45F1-B020-09030EA5AA45}"/>
              </a:ext>
            </a:extLst>
          </p:cNvPr>
          <p:cNvSpPr/>
          <p:nvPr/>
        </p:nvSpPr>
        <p:spPr>
          <a:xfrm flipV="1">
            <a:off x="1602571" y="1320235"/>
            <a:ext cx="1478054" cy="455702"/>
          </a:xfrm>
          <a:prstGeom prst="downArrowCallout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kstfelt 6">
            <a:extLst>
              <a:ext uri="{FF2B5EF4-FFF2-40B4-BE49-F238E27FC236}">
                <a16:creationId xmlns:a16="http://schemas.microsoft.com/office/drawing/2014/main" id="{7A15387F-E2E4-4221-BECD-2B69131B4058}"/>
              </a:ext>
            </a:extLst>
          </p:cNvPr>
          <p:cNvSpPr txBox="1"/>
          <p:nvPr/>
        </p:nvSpPr>
        <p:spPr>
          <a:xfrm>
            <a:off x="1622133" y="1468160"/>
            <a:ext cx="13978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Triglyceride content 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ncreases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 in HDL and IDL+ LDL fractions</a:t>
            </a:r>
          </a:p>
        </p:txBody>
      </p:sp>
      <p:sp>
        <p:nvSpPr>
          <p:cNvPr id="11" name="Tekstfelt 10">
            <a:extLst>
              <a:ext uri="{FF2B5EF4-FFF2-40B4-BE49-F238E27FC236}">
                <a16:creationId xmlns:a16="http://schemas.microsoft.com/office/drawing/2014/main" id="{BE54CFC7-27BE-4F5C-BC11-73CB8327F956}"/>
              </a:ext>
            </a:extLst>
          </p:cNvPr>
          <p:cNvSpPr txBox="1"/>
          <p:nvPr/>
        </p:nvSpPr>
        <p:spPr>
          <a:xfrm>
            <a:off x="3147046" y="313554"/>
            <a:ext cx="144117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Cholesterol content 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decreases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 in HDL and IDL+ LDL fractions</a:t>
            </a:r>
          </a:p>
        </p:txBody>
      </p:sp>
      <p:pic>
        <p:nvPicPr>
          <p:cNvPr id="22" name="Billede 21">
            <a:extLst>
              <a:ext uri="{FF2B5EF4-FFF2-40B4-BE49-F238E27FC236}">
                <a16:creationId xmlns:a16="http://schemas.microsoft.com/office/drawing/2014/main" id="{23696AEB-E147-4385-93E8-56122192548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746" b="61623"/>
          <a:stretch/>
        </p:blipFill>
        <p:spPr>
          <a:xfrm>
            <a:off x="74676" y="965817"/>
            <a:ext cx="1454297" cy="637809"/>
          </a:xfrm>
          <a:prstGeom prst="rect">
            <a:avLst/>
          </a:prstGeom>
        </p:spPr>
      </p:pic>
      <p:sp>
        <p:nvSpPr>
          <p:cNvPr id="23" name="Billedforklaring: nedadgående pil 22">
            <a:extLst>
              <a:ext uri="{FF2B5EF4-FFF2-40B4-BE49-F238E27FC236}">
                <a16:creationId xmlns:a16="http://schemas.microsoft.com/office/drawing/2014/main" id="{FCD003A4-AED1-41D2-AC28-57922D5FB564}"/>
              </a:ext>
            </a:extLst>
          </p:cNvPr>
          <p:cNvSpPr/>
          <p:nvPr/>
        </p:nvSpPr>
        <p:spPr>
          <a:xfrm>
            <a:off x="52066" y="340426"/>
            <a:ext cx="1478054" cy="457512"/>
          </a:xfrm>
          <a:prstGeom prst="downArrowCallout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kstfelt 23">
            <a:extLst>
              <a:ext uri="{FF2B5EF4-FFF2-40B4-BE49-F238E27FC236}">
                <a16:creationId xmlns:a16="http://schemas.microsoft.com/office/drawing/2014/main" id="{3B005F16-0029-43D5-AEB3-90F9A2679B04}"/>
              </a:ext>
            </a:extLst>
          </p:cNvPr>
          <p:cNvSpPr txBox="1"/>
          <p:nvPr/>
        </p:nvSpPr>
        <p:spPr>
          <a:xfrm>
            <a:off x="74676" y="340426"/>
            <a:ext cx="13978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In the general population, following normal meals</a:t>
            </a:r>
          </a:p>
        </p:txBody>
      </p:sp>
      <p:pic>
        <p:nvPicPr>
          <p:cNvPr id="13" name="Billede 12">
            <a:extLst>
              <a:ext uri="{FF2B5EF4-FFF2-40B4-BE49-F238E27FC236}">
                <a16:creationId xmlns:a16="http://schemas.microsoft.com/office/drawing/2014/main" id="{D659A8F4-31F0-470B-97CC-96E594CDB34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1711897" y="365475"/>
            <a:ext cx="1227580" cy="919248"/>
          </a:xfrm>
          <a:prstGeom prst="rect">
            <a:avLst/>
          </a:prstGeom>
        </p:spPr>
      </p:pic>
      <p:pic>
        <p:nvPicPr>
          <p:cNvPr id="25" name="Billede 24">
            <a:extLst>
              <a:ext uri="{FF2B5EF4-FFF2-40B4-BE49-F238E27FC236}">
                <a16:creationId xmlns:a16="http://schemas.microsoft.com/office/drawing/2014/main" id="{A1009C49-D39D-4927-87E2-ACE099096AC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81" r="-781"/>
          <a:stretch/>
        </p:blipFill>
        <p:spPr>
          <a:xfrm>
            <a:off x="3283844" y="844730"/>
            <a:ext cx="1227580" cy="919248"/>
          </a:xfrm>
          <a:prstGeom prst="rect">
            <a:avLst/>
          </a:prstGeom>
        </p:spPr>
      </p:pic>
      <p:sp>
        <p:nvSpPr>
          <p:cNvPr id="19" name="Rektangel: afrundede hjørner 18">
            <a:extLst>
              <a:ext uri="{FF2B5EF4-FFF2-40B4-BE49-F238E27FC236}">
                <a16:creationId xmlns:a16="http://schemas.microsoft.com/office/drawing/2014/main" id="{B7C99204-A62E-43A5-B2A5-33369D06A42B}"/>
              </a:ext>
            </a:extLst>
          </p:cNvPr>
          <p:cNvSpPr/>
          <p:nvPr/>
        </p:nvSpPr>
        <p:spPr>
          <a:xfrm>
            <a:off x="64318" y="824838"/>
            <a:ext cx="1489902" cy="939139"/>
          </a:xfrm>
          <a:prstGeom prst="roundRect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ktangel: afrundede hjørner 25">
            <a:extLst>
              <a:ext uri="{FF2B5EF4-FFF2-40B4-BE49-F238E27FC236}">
                <a16:creationId xmlns:a16="http://schemas.microsoft.com/office/drawing/2014/main" id="{C118369B-E7EA-40AC-B993-7E3F4A19EDDE}"/>
              </a:ext>
            </a:extLst>
          </p:cNvPr>
          <p:cNvSpPr/>
          <p:nvPr/>
        </p:nvSpPr>
        <p:spPr>
          <a:xfrm>
            <a:off x="1593632" y="337489"/>
            <a:ext cx="1489902" cy="947233"/>
          </a:xfrm>
          <a:prstGeom prst="roundRect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ktangel: afrundede hjørner 26">
            <a:extLst>
              <a:ext uri="{FF2B5EF4-FFF2-40B4-BE49-F238E27FC236}">
                <a16:creationId xmlns:a16="http://schemas.microsoft.com/office/drawing/2014/main" id="{94FC1742-41EF-4085-997D-50FC82CDADEF}"/>
              </a:ext>
            </a:extLst>
          </p:cNvPr>
          <p:cNvSpPr/>
          <p:nvPr/>
        </p:nvSpPr>
        <p:spPr>
          <a:xfrm>
            <a:off x="3152683" y="830737"/>
            <a:ext cx="1489902" cy="947233"/>
          </a:xfrm>
          <a:prstGeom prst="roundRect">
            <a:avLst/>
          </a:prstGeom>
          <a:noFill/>
          <a:ln w="9525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Billedforklaring: nedadgående pil 27">
            <a:extLst>
              <a:ext uri="{FF2B5EF4-FFF2-40B4-BE49-F238E27FC236}">
                <a16:creationId xmlns:a16="http://schemas.microsoft.com/office/drawing/2014/main" id="{010D2D8A-F107-4A9D-8C7C-9B4B0EFA931D}"/>
              </a:ext>
            </a:extLst>
          </p:cNvPr>
          <p:cNvSpPr/>
          <p:nvPr/>
        </p:nvSpPr>
        <p:spPr>
          <a:xfrm rot="10800000" flipV="1">
            <a:off x="3158608" y="342235"/>
            <a:ext cx="1478054" cy="455702"/>
          </a:xfrm>
          <a:prstGeom prst="downArrowCallout">
            <a:avLst/>
          </a:prstGeom>
          <a:noFill/>
          <a:ln w="1905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573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2</TotalTime>
  <Words>49</Words>
  <Application>Microsoft Office PowerPoint</Application>
  <PresentationFormat>Brugerdefineret</PresentationFormat>
  <Paragraphs>5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ia Østergaard Johansen</dc:creator>
  <cp:lastModifiedBy>Mia Østergaard Johansen</cp:lastModifiedBy>
  <cp:revision>12</cp:revision>
  <dcterms:created xsi:type="dcterms:W3CDTF">2022-12-20T13:31:52Z</dcterms:created>
  <dcterms:modified xsi:type="dcterms:W3CDTF">2023-01-02T13:42:50Z</dcterms:modified>
</cp:coreProperties>
</file>